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16" userDrawn="1">
          <p15:clr>
            <a:srgbClr val="A4A3A4"/>
          </p15:clr>
        </p15:guide>
        <p15:guide id="2" pos="148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606" autoAdjust="0"/>
    <p:restoredTop sz="95388" autoAdjust="0"/>
  </p:normalViewPr>
  <p:slideViewPr>
    <p:cSldViewPr snapToGrid="0">
      <p:cViewPr varScale="1">
        <p:scale>
          <a:sx n="107" d="100"/>
          <a:sy n="107" d="100"/>
        </p:scale>
        <p:origin x="924" y="102"/>
      </p:cViewPr>
      <p:guideLst>
        <p:guide orient="horz" pos="2616"/>
        <p:guide pos="148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B0A1A6-A393-E6F0-C493-C577C8C3BA6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F8D9849-5A19-2F03-F200-0A9546B6E5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70CDA7-B2E7-3361-2E5B-FAB636433D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F28D5-5463-4C99-BE3D-59335BCBB430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CA1244-365F-FCCD-84C6-6AEBB3AC51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25689C-594A-2E78-D6E5-EFDE35097E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D26E8-74FA-4EFD-8DA4-B3FE06A2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8462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9AC6F6-BA68-31B2-5B3A-BEE57C9903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853B02-9CA5-5229-676A-0E00CBCDE5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78FED1-D74A-2317-1B37-D4437D3C54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F28D5-5463-4C99-BE3D-59335BCBB430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24B956-842C-9669-98CD-FC292E187A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01D6C5-612E-E35E-F475-82107C09F0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D26E8-74FA-4EFD-8DA4-B3FE06A2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7064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06F73A9-151E-26BB-0A78-5CD8908EAAC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357134C-A35D-9A45-8B3F-B3FBC9488F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82D550-62D0-7133-D7E5-3A6915BFAB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F28D5-5463-4C99-BE3D-59335BCBB430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4DEE7D-F389-4521-4F57-64360D7F98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55D4CF-FE36-E7E8-2A27-A6EA138209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D26E8-74FA-4EFD-8DA4-B3FE06A2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9332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FB88F6-41FB-D439-F288-1BFD604C56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58F974-1CE3-58AF-A5FB-966B7A830B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020164-058B-3A7C-DF84-EC4590671B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F28D5-5463-4C99-BE3D-59335BCBB430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798D38-812E-D9C9-E4EB-5B2AE8291E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239702-271A-6C35-32D5-20745CE531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D26E8-74FA-4EFD-8DA4-B3FE06A2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89871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1011CE-F114-EF3F-5D36-659FF8F028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C6DD86-16D9-48E2-000B-7A166D0A5F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0AD763-1DB2-EF40-14EA-36181C02D8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F28D5-5463-4C99-BE3D-59335BCBB430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76BC3D-DC82-3618-6E78-AD444DC869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1B1AC5-87AA-B404-C1D5-D96422FC15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D26E8-74FA-4EFD-8DA4-B3FE06A2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503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62CA0B-5859-1685-E380-25D9DBC35D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77756B-B015-1414-B187-73BA0AAB55F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D40566-EA7A-DD7C-3F6B-CBF6E78E0B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95E318-A086-A03A-77A3-E42AC0A8B0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F28D5-5463-4C99-BE3D-59335BCBB430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302441-77BF-CF86-2BB7-63C7CEC564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D07681-5008-3BBF-192E-10C2A2883A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D26E8-74FA-4EFD-8DA4-B3FE06A2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453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7B5552-883B-4EC9-617E-22A25EF212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4892D0-1500-09AB-CECE-BF61DEA22C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50C6313-B8F7-94B4-65A3-45A24F1464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820B26A-1EB1-FE3D-3082-D83C38C114D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AC7BF23-87E3-ACDD-826E-92CAF6838EF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46D49E9-DE63-368E-6C6D-1CA35A61A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F28D5-5463-4C99-BE3D-59335BCBB430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F791F4E-DDB3-642A-B2F7-548031723F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75A25E7-8FE6-A854-EC1A-2F709F9E31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D26E8-74FA-4EFD-8DA4-B3FE06A2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1747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5A111D-8ADF-54DB-0C83-9D2036F8FD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64033CD-59C3-E845-B5C0-48DAE5933B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F28D5-5463-4C99-BE3D-59335BCBB430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341AD9F-AC02-825B-559A-1B9F41DCE9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49E947C-7C41-4742-A650-AB6AA1F72C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D26E8-74FA-4EFD-8DA4-B3FE06A2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1577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9B0C8BB-67F7-51E8-9FEC-043C860FF5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F28D5-5463-4C99-BE3D-59335BCBB430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0DD8083-62CB-D0AE-6034-54388D48B7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BFDDAB-36F3-D6E8-D804-A3F64F1061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D26E8-74FA-4EFD-8DA4-B3FE06A2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778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A7B213-AECF-F30A-1CEA-0D72C10A3A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68CFB5-ADBC-FE60-B0E1-763AA738A37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1307C73-FD12-25F3-29F7-C34EC3001F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D04E4D3-9CB6-5C55-D128-51AAE7082B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F28D5-5463-4C99-BE3D-59335BCBB430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C0ED58-F67E-C4A9-FE85-C2487A3094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B5D911-77E6-EA30-DC0F-E1E6F07FF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D26E8-74FA-4EFD-8DA4-B3FE06A2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004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34C483-7783-3A9C-8438-8CAE5D5565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34B6F7B-D7A0-8BED-9C94-3235442E8AC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8C8B24-168A-191C-16DA-A12BDB66FA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9CA673-1A01-2E8A-0D10-2BAB207D75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F28D5-5463-4C99-BE3D-59335BCBB430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04F758-E8B8-E026-171E-30AFA47C90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C9E2B8-A39B-3819-E979-D850A10CB3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D26E8-74FA-4EFD-8DA4-B3FE06A2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077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706D627-6CF0-0043-21B7-B039BF170F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EB40CF-578E-5F9D-8462-10D4FEAA2D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4D7D91-F8C2-F84F-2992-41F869CB83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0FF28D5-5463-4C99-BE3D-59335BCBB430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A62CC8-07B1-8BF5-47B9-125D1FD9CBE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3439E0-62E0-AEE1-7044-6A4338816C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8DD26E8-74FA-4EFD-8DA4-B3FE06A2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231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5480298F-CEFD-02DB-BEF2-B42509B37D62}"/>
              </a:ext>
            </a:extLst>
          </p:cNvPr>
          <p:cNvGrpSpPr/>
          <p:nvPr/>
        </p:nvGrpSpPr>
        <p:grpSpPr>
          <a:xfrm>
            <a:off x="2117626" y="1223962"/>
            <a:ext cx="7878861" cy="4746134"/>
            <a:chOff x="2117626" y="1223962"/>
            <a:chExt cx="7878861" cy="4746134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AC21ABCE-17F5-45CF-234F-80FDD37EB7C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95512" y="1223962"/>
              <a:ext cx="7800975" cy="4410075"/>
            </a:xfrm>
            <a:prstGeom prst="rect">
              <a:avLst/>
            </a:prstGeom>
          </p:spPr>
        </p:pic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8AC5E6C1-34B2-DE2C-1F03-0EE083235B54}"/>
                </a:ext>
              </a:extLst>
            </p:cNvPr>
            <p:cNvSpPr/>
            <p:nvPr/>
          </p:nvSpPr>
          <p:spPr>
            <a:xfrm>
              <a:off x="2195512" y="1938020"/>
              <a:ext cx="616269" cy="273812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2F4BBE41-A582-70CD-F91F-94DA2F5FB6D4}"/>
                </a:ext>
              </a:extLst>
            </p:cNvPr>
            <p:cNvSpPr txBox="1"/>
            <p:nvPr/>
          </p:nvSpPr>
          <p:spPr>
            <a:xfrm>
              <a:off x="3869802" y="5693097"/>
              <a:ext cx="481223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i="0" u="none" strike="noStrike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1.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ta diversity dispersion across intestinal segments (P &lt; 0.001). 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D4AC32B-2128-CEA3-B8CC-1D0A8FC00D5F}"/>
                </a:ext>
              </a:extLst>
            </p:cNvPr>
            <p:cNvSpPr txBox="1"/>
            <p:nvPr/>
          </p:nvSpPr>
          <p:spPr>
            <a:xfrm rot="16200000">
              <a:off x="1305277" y="3139715"/>
              <a:ext cx="19632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tance to centroi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B516972-06AD-4139-9202-D5A889F8BA77}"/>
                </a:ext>
              </a:extLst>
            </p:cNvPr>
            <p:cNvSpPr txBox="1"/>
            <p:nvPr/>
          </p:nvSpPr>
          <p:spPr>
            <a:xfrm rot="16200000">
              <a:off x="2303410" y="4242293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C950E0E-C08F-D15E-4CE4-456F11659CC8}"/>
                </a:ext>
              </a:extLst>
            </p:cNvPr>
            <p:cNvSpPr txBox="1"/>
            <p:nvPr/>
          </p:nvSpPr>
          <p:spPr>
            <a:xfrm rot="16200000">
              <a:off x="2301927" y="3557581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8C616F0-1444-F0E1-F227-0B81FFA96034}"/>
                </a:ext>
              </a:extLst>
            </p:cNvPr>
            <p:cNvSpPr txBox="1"/>
            <p:nvPr/>
          </p:nvSpPr>
          <p:spPr>
            <a:xfrm rot="16200000">
              <a:off x="2300444" y="2872869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2E2F713-CE5A-7F01-ECDC-90820F58F89A}"/>
                </a:ext>
              </a:extLst>
            </p:cNvPr>
            <p:cNvSpPr txBox="1"/>
            <p:nvPr/>
          </p:nvSpPr>
          <p:spPr>
            <a:xfrm rot="16200000">
              <a:off x="2298955" y="2188157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031C1529-7A9F-2720-A03F-D9B3DF226DF7}"/>
                </a:ext>
              </a:extLst>
            </p:cNvPr>
            <p:cNvSpPr/>
            <p:nvPr/>
          </p:nvSpPr>
          <p:spPr>
            <a:xfrm rot="5400000">
              <a:off x="5942016" y="1824113"/>
              <a:ext cx="667804" cy="66886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0626B221-AB82-5A00-8FDB-5DFF9CB5D981}"/>
                </a:ext>
              </a:extLst>
            </p:cNvPr>
            <p:cNvSpPr txBox="1"/>
            <p:nvPr/>
          </p:nvSpPr>
          <p:spPr>
            <a:xfrm>
              <a:off x="3430146" y="4818126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ca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0AEF4A7-41E9-F79B-1B94-E79668DB9D5E}"/>
                </a:ext>
              </a:extLst>
            </p:cNvPr>
            <p:cNvSpPr txBox="1"/>
            <p:nvPr/>
          </p:nvSpPr>
          <p:spPr>
            <a:xfrm>
              <a:off x="4495332" y="4814316"/>
              <a:ext cx="11469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uodenum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3BFBD48-D505-EBA2-0B80-CCAE7B048686}"/>
                </a:ext>
              </a:extLst>
            </p:cNvPr>
            <p:cNvSpPr txBox="1"/>
            <p:nvPr/>
          </p:nvSpPr>
          <p:spPr>
            <a:xfrm>
              <a:off x="5812346" y="4815064"/>
              <a:ext cx="9387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eces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258EB5F-DBEF-F0E0-018A-E1DD7A6D49A4}"/>
                </a:ext>
              </a:extLst>
            </p:cNvPr>
            <p:cNvSpPr txBox="1"/>
            <p:nvPr/>
          </p:nvSpPr>
          <p:spPr>
            <a:xfrm>
              <a:off x="7068893" y="4815840"/>
              <a:ext cx="9387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leum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950BF00-8055-033F-F665-1AA250394516}"/>
                </a:ext>
              </a:extLst>
            </p:cNvPr>
            <p:cNvSpPr txBox="1"/>
            <p:nvPr/>
          </p:nvSpPr>
          <p:spPr>
            <a:xfrm>
              <a:off x="8321630" y="4815840"/>
              <a:ext cx="9387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Jejunum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0EE6B4B-7E59-5F15-DD6B-AD1F778358D8}"/>
                </a:ext>
              </a:extLst>
            </p:cNvPr>
            <p:cNvSpPr txBox="1"/>
            <p:nvPr/>
          </p:nvSpPr>
          <p:spPr>
            <a:xfrm>
              <a:off x="5324942" y="5168873"/>
              <a:ext cx="19019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stinal Segment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66526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D87B681F-0952-791B-111C-5056C0E897BE}"/>
              </a:ext>
            </a:extLst>
          </p:cNvPr>
          <p:cNvGrpSpPr/>
          <p:nvPr/>
        </p:nvGrpSpPr>
        <p:grpSpPr>
          <a:xfrm>
            <a:off x="2119425" y="1223962"/>
            <a:ext cx="7877062" cy="4820035"/>
            <a:chOff x="2119425" y="1223962"/>
            <a:chExt cx="7877062" cy="4820035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654212C6-6992-66E0-8645-69C728E08FA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95512" y="1223962"/>
              <a:ext cx="7800975" cy="4410075"/>
            </a:xfrm>
            <a:prstGeom prst="rect">
              <a:avLst/>
            </a:prstGeom>
          </p:spPr>
        </p:pic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E38482F1-3B60-88C7-779E-81B55B8663F8}"/>
                </a:ext>
              </a:extLst>
            </p:cNvPr>
            <p:cNvSpPr/>
            <p:nvPr/>
          </p:nvSpPr>
          <p:spPr>
            <a:xfrm>
              <a:off x="2195512" y="1938020"/>
              <a:ext cx="616269" cy="273812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BF553618-30E8-3714-AF62-36B1705F64CB}"/>
                </a:ext>
              </a:extLst>
            </p:cNvPr>
            <p:cNvSpPr/>
            <p:nvPr/>
          </p:nvSpPr>
          <p:spPr>
            <a:xfrm rot="5400000">
              <a:off x="5942016" y="1824113"/>
              <a:ext cx="667804" cy="66886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2281E16B-D3AD-FFE5-2B97-9F7273BB4207}"/>
                </a:ext>
              </a:extLst>
            </p:cNvPr>
            <p:cNvSpPr txBox="1"/>
            <p:nvPr/>
          </p:nvSpPr>
          <p:spPr>
            <a:xfrm>
              <a:off x="4156385" y="5766998"/>
              <a:ext cx="430404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i="0" u="none" strike="noStrike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2.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ta diversity dispersion across bird types (P = 0.075). 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5F07FA95-2344-7934-6B1D-30B325F552A6}"/>
                </a:ext>
              </a:extLst>
            </p:cNvPr>
            <p:cNvSpPr txBox="1"/>
            <p:nvPr/>
          </p:nvSpPr>
          <p:spPr>
            <a:xfrm>
              <a:off x="3841242" y="4812863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roiler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ECFBDBD-992E-2FCC-E2C9-92A1D7469380}"/>
                </a:ext>
              </a:extLst>
            </p:cNvPr>
            <p:cNvSpPr txBox="1"/>
            <p:nvPr/>
          </p:nvSpPr>
          <p:spPr>
            <a:xfrm>
              <a:off x="5700809" y="4812863"/>
              <a:ext cx="11469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yer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715A61B-6ED8-E423-7113-26900FAFF8B1}"/>
                </a:ext>
              </a:extLst>
            </p:cNvPr>
            <p:cNvSpPr txBox="1"/>
            <p:nvPr/>
          </p:nvSpPr>
          <p:spPr>
            <a:xfrm>
              <a:off x="7881176" y="4812863"/>
              <a:ext cx="9387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ther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32EB107-5CA6-7DA3-567E-017FF58CE787}"/>
                </a:ext>
              </a:extLst>
            </p:cNvPr>
            <p:cNvSpPr txBox="1"/>
            <p:nvPr/>
          </p:nvSpPr>
          <p:spPr>
            <a:xfrm>
              <a:off x="5357432" y="5170723"/>
              <a:ext cx="19019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rd Types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8DAB13A-11D6-653E-C614-BA328D1A07F3}"/>
                </a:ext>
              </a:extLst>
            </p:cNvPr>
            <p:cNvSpPr txBox="1"/>
            <p:nvPr/>
          </p:nvSpPr>
          <p:spPr>
            <a:xfrm rot="16200000">
              <a:off x="1307076" y="3142711"/>
              <a:ext cx="19632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tance to centroi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77808D4-EBAF-AB0C-C7B4-C431A55D55F7}"/>
                </a:ext>
              </a:extLst>
            </p:cNvPr>
            <p:cNvSpPr txBox="1"/>
            <p:nvPr/>
          </p:nvSpPr>
          <p:spPr>
            <a:xfrm rot="16200000">
              <a:off x="2303172" y="4160013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5272914-4BD4-02D2-DD94-C4D8D734F53B}"/>
                </a:ext>
              </a:extLst>
            </p:cNvPr>
            <p:cNvSpPr txBox="1"/>
            <p:nvPr/>
          </p:nvSpPr>
          <p:spPr>
            <a:xfrm rot="16200000">
              <a:off x="2304676" y="3621738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53DACFF3-0865-C42B-C251-66528BC0791E}"/>
                </a:ext>
              </a:extLst>
            </p:cNvPr>
            <p:cNvSpPr txBox="1"/>
            <p:nvPr/>
          </p:nvSpPr>
          <p:spPr>
            <a:xfrm rot="16200000">
              <a:off x="2304676" y="3079652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4B24CD5-B4A4-12C4-041B-B3B9EF3474C0}"/>
                </a:ext>
              </a:extLst>
            </p:cNvPr>
            <p:cNvSpPr txBox="1"/>
            <p:nvPr/>
          </p:nvSpPr>
          <p:spPr>
            <a:xfrm rot="16200000">
              <a:off x="2304677" y="2546162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7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2F90D6B-FA1A-F2A3-073E-1507CCAEBB51}"/>
                </a:ext>
              </a:extLst>
            </p:cNvPr>
            <p:cNvSpPr txBox="1"/>
            <p:nvPr/>
          </p:nvSpPr>
          <p:spPr>
            <a:xfrm rot="16200000">
              <a:off x="2303172" y="2003101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375997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EC163F1-F456-9D4D-2177-65B16F69ED6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EEBEDB37-F27C-E5DD-78CC-CDF95542DCAE}"/>
              </a:ext>
            </a:extLst>
          </p:cNvPr>
          <p:cNvGrpSpPr/>
          <p:nvPr/>
        </p:nvGrpSpPr>
        <p:grpSpPr>
          <a:xfrm>
            <a:off x="2118155" y="1223962"/>
            <a:ext cx="7878332" cy="4824389"/>
            <a:chOff x="2118155" y="1223962"/>
            <a:chExt cx="7878332" cy="4824389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C1737A03-FF61-3845-EC2D-8A432FEB434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95512" y="1223962"/>
              <a:ext cx="7800975" cy="4410075"/>
            </a:xfrm>
            <a:prstGeom prst="rect">
              <a:avLst/>
            </a:prstGeom>
          </p:spPr>
        </p:pic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69669D2E-C8DF-5011-9537-B18C157896E5}"/>
                </a:ext>
              </a:extLst>
            </p:cNvPr>
            <p:cNvSpPr/>
            <p:nvPr/>
          </p:nvSpPr>
          <p:spPr>
            <a:xfrm>
              <a:off x="2195512" y="1938020"/>
              <a:ext cx="616269" cy="273812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D598995B-4A8E-81E8-804D-25647A6E5FC4}"/>
                </a:ext>
              </a:extLst>
            </p:cNvPr>
            <p:cNvSpPr/>
            <p:nvPr/>
          </p:nvSpPr>
          <p:spPr>
            <a:xfrm rot="5400000">
              <a:off x="5942016" y="1824113"/>
              <a:ext cx="667804" cy="66886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DA2BE27E-2DC9-080E-1E8E-50EBCCF4288A}"/>
                </a:ext>
              </a:extLst>
            </p:cNvPr>
            <p:cNvSpPr txBox="1"/>
            <p:nvPr/>
          </p:nvSpPr>
          <p:spPr>
            <a:xfrm>
              <a:off x="4250653" y="5762644"/>
              <a:ext cx="4115510" cy="28570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i="0" u="none" strike="noStrike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3.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ta diversity dispersion across housing (P &lt; 0.001). 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42ECD68-5F81-890D-B005-BF64F59C3BA1}"/>
                </a:ext>
              </a:extLst>
            </p:cNvPr>
            <p:cNvSpPr txBox="1"/>
            <p:nvPr/>
          </p:nvSpPr>
          <p:spPr>
            <a:xfrm>
              <a:off x="3603752" y="4816856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ges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1832E39-AA87-E64B-3909-30014A3F2C8F}"/>
                </a:ext>
              </a:extLst>
            </p:cNvPr>
            <p:cNvSpPr txBox="1"/>
            <p:nvPr/>
          </p:nvSpPr>
          <p:spPr>
            <a:xfrm>
              <a:off x="4902267" y="4816856"/>
              <a:ext cx="11469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ges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04F1C56-77E6-73E7-C4AE-F94C38886DFA}"/>
                </a:ext>
              </a:extLst>
            </p:cNvPr>
            <p:cNvSpPr txBox="1"/>
            <p:nvPr/>
          </p:nvSpPr>
          <p:spPr>
            <a:xfrm>
              <a:off x="6555296" y="4815840"/>
              <a:ext cx="9387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xed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4BDB7DA-F2D7-BA4D-67E3-413CE688DB93}"/>
                </a:ext>
              </a:extLst>
            </p:cNvPr>
            <p:cNvSpPr txBox="1"/>
            <p:nvPr/>
          </p:nvSpPr>
          <p:spPr>
            <a:xfrm>
              <a:off x="8111810" y="4810760"/>
              <a:ext cx="9387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ns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E9539D4-EEFF-C5DA-3D9E-90FCE8088402}"/>
                </a:ext>
              </a:extLst>
            </p:cNvPr>
            <p:cNvSpPr txBox="1"/>
            <p:nvPr/>
          </p:nvSpPr>
          <p:spPr>
            <a:xfrm>
              <a:off x="5357432" y="5175433"/>
              <a:ext cx="19019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using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F5106B6-D634-7D61-94FB-954C87174F87}"/>
                </a:ext>
              </a:extLst>
            </p:cNvPr>
            <p:cNvSpPr txBox="1"/>
            <p:nvPr/>
          </p:nvSpPr>
          <p:spPr>
            <a:xfrm rot="16200000">
              <a:off x="1305806" y="3140261"/>
              <a:ext cx="19632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tance to centroi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738ABD7-F169-4E7F-6031-3D3AF51792DF}"/>
                </a:ext>
              </a:extLst>
            </p:cNvPr>
            <p:cNvSpPr txBox="1"/>
            <p:nvPr/>
          </p:nvSpPr>
          <p:spPr>
            <a:xfrm rot="16200000">
              <a:off x="2305306" y="4036091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F9F83AC-F8BA-5E3A-6551-DB3EAAEE9A01}"/>
                </a:ext>
              </a:extLst>
            </p:cNvPr>
            <p:cNvSpPr txBox="1"/>
            <p:nvPr/>
          </p:nvSpPr>
          <p:spPr>
            <a:xfrm rot="16200000">
              <a:off x="2305306" y="3383592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5DBB820-C535-51DF-83CC-64B78A71EDCD}"/>
                </a:ext>
              </a:extLst>
            </p:cNvPr>
            <p:cNvSpPr txBox="1"/>
            <p:nvPr/>
          </p:nvSpPr>
          <p:spPr>
            <a:xfrm rot="16200000">
              <a:off x="2305306" y="2713802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F96D142-E8DE-B985-F55B-37CB496C27ED}"/>
                </a:ext>
              </a:extLst>
            </p:cNvPr>
            <p:cNvSpPr txBox="1"/>
            <p:nvPr/>
          </p:nvSpPr>
          <p:spPr>
            <a:xfrm rot="16200000">
              <a:off x="2305306" y="2054172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432457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EB95FFC-C8E5-A0DF-98C6-CEB225AF89C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13F5A55A-5C31-6C74-B529-6ADDB5937059}"/>
              </a:ext>
            </a:extLst>
          </p:cNvPr>
          <p:cNvGrpSpPr/>
          <p:nvPr/>
        </p:nvGrpSpPr>
        <p:grpSpPr>
          <a:xfrm>
            <a:off x="2119425" y="1223962"/>
            <a:ext cx="7877062" cy="4882291"/>
            <a:chOff x="2119425" y="1223962"/>
            <a:chExt cx="7877062" cy="4882291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4D6C5980-3333-67E3-9D58-48CBF60BD60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95512" y="1223962"/>
              <a:ext cx="7800975" cy="4410075"/>
            </a:xfrm>
            <a:prstGeom prst="rect">
              <a:avLst/>
            </a:prstGeom>
          </p:spPr>
        </p:pic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22FD73BB-724A-CCE1-59D5-48087D6ACF41}"/>
                </a:ext>
              </a:extLst>
            </p:cNvPr>
            <p:cNvSpPr/>
            <p:nvPr/>
          </p:nvSpPr>
          <p:spPr>
            <a:xfrm>
              <a:off x="2195512" y="1938020"/>
              <a:ext cx="616269" cy="273812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5756BDFF-99AC-8597-AA70-2C893E47583D}"/>
                </a:ext>
              </a:extLst>
            </p:cNvPr>
            <p:cNvSpPr/>
            <p:nvPr/>
          </p:nvSpPr>
          <p:spPr>
            <a:xfrm rot="5400000">
              <a:off x="5942016" y="1824113"/>
              <a:ext cx="667804" cy="66886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26725381-9530-A4C4-0838-04B728D9AA8E}"/>
                </a:ext>
              </a:extLst>
            </p:cNvPr>
            <p:cNvSpPr txBox="1"/>
            <p:nvPr/>
          </p:nvSpPr>
          <p:spPr>
            <a:xfrm>
              <a:off x="3727105" y="5829254"/>
              <a:ext cx="502991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i="0" u="none" strike="noStrike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4.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ta diversity dispersion across hypervariable regions (P &lt; 0.001). 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D77F7045-C2D8-E473-A23F-76452CB684CE}"/>
                </a:ext>
              </a:extLst>
            </p:cNvPr>
            <p:cNvSpPr txBox="1"/>
            <p:nvPr/>
          </p:nvSpPr>
          <p:spPr>
            <a:xfrm>
              <a:off x="3198552" y="4812236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-V2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04048BA-85BC-D3C8-7978-448C2F79D83A}"/>
                </a:ext>
              </a:extLst>
            </p:cNvPr>
            <p:cNvSpPr txBox="1"/>
            <p:nvPr/>
          </p:nvSpPr>
          <p:spPr>
            <a:xfrm>
              <a:off x="5109783" y="5171134"/>
              <a:ext cx="23311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ypervariable Regions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7FCED5B-ED5F-7167-5A7E-0E3DD1596E9A}"/>
                </a:ext>
              </a:extLst>
            </p:cNvPr>
            <p:cNvSpPr txBox="1"/>
            <p:nvPr/>
          </p:nvSpPr>
          <p:spPr>
            <a:xfrm rot="16200000">
              <a:off x="1307076" y="3140261"/>
              <a:ext cx="19632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tance to centroi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98A5A03-A52B-82F1-6ABC-4A074BBFEE64}"/>
                </a:ext>
              </a:extLst>
            </p:cNvPr>
            <p:cNvSpPr txBox="1"/>
            <p:nvPr/>
          </p:nvSpPr>
          <p:spPr>
            <a:xfrm rot="16200000">
              <a:off x="2301240" y="4199233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537A5B6-6422-0E50-5A40-ED6BA4290C11}"/>
                </a:ext>
              </a:extLst>
            </p:cNvPr>
            <p:cNvSpPr txBox="1"/>
            <p:nvPr/>
          </p:nvSpPr>
          <p:spPr>
            <a:xfrm rot="16200000">
              <a:off x="2301625" y="3472061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249C601-91A3-063E-BBEE-D5543856CF8A}"/>
                </a:ext>
              </a:extLst>
            </p:cNvPr>
            <p:cNvSpPr txBox="1"/>
            <p:nvPr/>
          </p:nvSpPr>
          <p:spPr>
            <a:xfrm rot="16200000">
              <a:off x="2300818" y="2738062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6679E57-A34D-96E2-140B-3F83A19A0573}"/>
                </a:ext>
              </a:extLst>
            </p:cNvPr>
            <p:cNvSpPr txBox="1"/>
            <p:nvPr/>
          </p:nvSpPr>
          <p:spPr>
            <a:xfrm rot="16200000">
              <a:off x="2300396" y="2014310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3874D97-7CA3-B6FA-1F86-465C2877D948}"/>
                </a:ext>
              </a:extLst>
            </p:cNvPr>
            <p:cNvSpPr txBox="1"/>
            <p:nvPr/>
          </p:nvSpPr>
          <p:spPr>
            <a:xfrm rot="16200000">
              <a:off x="2299758" y="3836923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3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2620FE0-274C-FAE1-BC70-D35D73E0037B}"/>
                </a:ext>
              </a:extLst>
            </p:cNvPr>
            <p:cNvSpPr txBox="1"/>
            <p:nvPr/>
          </p:nvSpPr>
          <p:spPr>
            <a:xfrm rot="16200000">
              <a:off x="2301241" y="3097442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41765F6-3F2A-F11F-C3E4-0D44F1AA7F06}"/>
                </a:ext>
              </a:extLst>
            </p:cNvPr>
            <p:cNvSpPr txBox="1"/>
            <p:nvPr/>
          </p:nvSpPr>
          <p:spPr>
            <a:xfrm rot="16200000">
              <a:off x="2300838" y="2381800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7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6AE1A59-4BC1-287B-2605-222E7D09C574}"/>
                </a:ext>
              </a:extLst>
            </p:cNvPr>
            <p:cNvSpPr txBox="1"/>
            <p:nvPr/>
          </p:nvSpPr>
          <p:spPr>
            <a:xfrm>
              <a:off x="3978690" y="4812235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-V3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8AD3E7D-5ADB-4459-94F2-F3405643D349}"/>
                </a:ext>
              </a:extLst>
            </p:cNvPr>
            <p:cNvSpPr txBox="1"/>
            <p:nvPr/>
          </p:nvSpPr>
          <p:spPr>
            <a:xfrm>
              <a:off x="4743166" y="4811205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3-V4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AFC49C1-3DFC-B94B-2F3B-42BB4F87A3A8}"/>
                </a:ext>
              </a:extLst>
            </p:cNvPr>
            <p:cNvSpPr txBox="1"/>
            <p:nvPr/>
          </p:nvSpPr>
          <p:spPr>
            <a:xfrm>
              <a:off x="5512718" y="4810578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3-V5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C7B25F67-AD1D-A14C-6C3E-C12B43B8AF2A}"/>
                </a:ext>
              </a:extLst>
            </p:cNvPr>
            <p:cNvSpPr txBox="1"/>
            <p:nvPr/>
          </p:nvSpPr>
          <p:spPr>
            <a:xfrm>
              <a:off x="6277616" y="4813235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3-V5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40EC4BC-0DB9-7919-E0A2-818A7A9D0F05}"/>
                </a:ext>
              </a:extLst>
            </p:cNvPr>
            <p:cNvSpPr txBox="1"/>
            <p:nvPr/>
          </p:nvSpPr>
          <p:spPr>
            <a:xfrm>
              <a:off x="7054883" y="4811205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4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6494D4A-B04D-5828-41B5-8645CEC34A92}"/>
                </a:ext>
              </a:extLst>
            </p:cNvPr>
            <p:cNvSpPr txBox="1"/>
            <p:nvPr/>
          </p:nvSpPr>
          <p:spPr>
            <a:xfrm>
              <a:off x="7844348" y="4810225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4-V5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ED69758-1348-9103-F068-355CDE5D6A60}"/>
                </a:ext>
              </a:extLst>
            </p:cNvPr>
            <p:cNvSpPr txBox="1"/>
            <p:nvPr/>
          </p:nvSpPr>
          <p:spPr>
            <a:xfrm>
              <a:off x="8601204" y="4811205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6-V8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156398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FFA4AC9-DF63-743D-6EBA-D1AF4A7393E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>
            <a:extLst>
              <a:ext uri="{FF2B5EF4-FFF2-40B4-BE49-F238E27FC236}">
                <a16:creationId xmlns:a16="http://schemas.microsoft.com/office/drawing/2014/main" id="{02D3FF80-806C-870C-8D62-AC4698AE5A9A}"/>
              </a:ext>
            </a:extLst>
          </p:cNvPr>
          <p:cNvGrpSpPr/>
          <p:nvPr/>
        </p:nvGrpSpPr>
        <p:grpSpPr>
          <a:xfrm>
            <a:off x="2121330" y="1223962"/>
            <a:ext cx="7875157" cy="4820036"/>
            <a:chOff x="2121330" y="1223962"/>
            <a:chExt cx="7875157" cy="4820036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AA327042-2866-80E1-AA82-1EF024F3D58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95512" y="1223962"/>
              <a:ext cx="7800975" cy="4410075"/>
            </a:xfrm>
            <a:prstGeom prst="rect">
              <a:avLst/>
            </a:prstGeom>
          </p:spPr>
        </p:pic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B96F85EF-0548-35AC-E6A0-0E989EBCBAFE}"/>
                </a:ext>
              </a:extLst>
            </p:cNvPr>
            <p:cNvSpPr/>
            <p:nvPr/>
          </p:nvSpPr>
          <p:spPr>
            <a:xfrm>
              <a:off x="2195512" y="1938020"/>
              <a:ext cx="616269" cy="273812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77252960-CD3E-D7A8-3630-A1D07B790753}"/>
                </a:ext>
              </a:extLst>
            </p:cNvPr>
            <p:cNvSpPr/>
            <p:nvPr/>
          </p:nvSpPr>
          <p:spPr>
            <a:xfrm rot="5400000">
              <a:off x="5942016" y="1824113"/>
              <a:ext cx="667804" cy="66886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AC7D493D-8D4B-2832-B93D-E0CBD3619A4F}"/>
                </a:ext>
              </a:extLst>
            </p:cNvPr>
            <p:cNvSpPr txBox="1"/>
            <p:nvPr/>
          </p:nvSpPr>
          <p:spPr>
            <a:xfrm>
              <a:off x="4175238" y="5766998"/>
              <a:ext cx="4266339" cy="27700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i="0" u="none" strike="noStrike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5.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ta diversity dispersion across continents (P &lt; 0.001). 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3A5D8DA8-94F1-CDF7-F079-1CE7635EBD00}"/>
                </a:ext>
              </a:extLst>
            </p:cNvPr>
            <p:cNvSpPr txBox="1"/>
            <p:nvPr/>
          </p:nvSpPr>
          <p:spPr>
            <a:xfrm>
              <a:off x="3433572" y="4812357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frica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4186AFC-6406-0AFD-FEBD-0BE923330DDA}"/>
                </a:ext>
              </a:extLst>
            </p:cNvPr>
            <p:cNvSpPr txBox="1"/>
            <p:nvPr/>
          </p:nvSpPr>
          <p:spPr>
            <a:xfrm>
              <a:off x="4457132" y="4812357"/>
              <a:ext cx="11469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ia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B1F9D4A-32CB-03AC-66F8-002B70B14696}"/>
                </a:ext>
              </a:extLst>
            </p:cNvPr>
            <p:cNvSpPr txBox="1"/>
            <p:nvPr/>
          </p:nvSpPr>
          <p:spPr>
            <a:xfrm>
              <a:off x="5831396" y="4810071"/>
              <a:ext cx="9387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urope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67391FC-CA3B-C63E-CEC7-B6C5F19FCD90}"/>
                </a:ext>
              </a:extLst>
            </p:cNvPr>
            <p:cNvSpPr txBox="1"/>
            <p:nvPr/>
          </p:nvSpPr>
          <p:spPr>
            <a:xfrm>
              <a:off x="7049455" y="4813881"/>
              <a:ext cx="9387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ne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C75C153-6A1E-49EE-96CD-CE21985744C9}"/>
                </a:ext>
              </a:extLst>
            </p:cNvPr>
            <p:cNvSpPr txBox="1"/>
            <p:nvPr/>
          </p:nvSpPr>
          <p:spPr>
            <a:xfrm>
              <a:off x="8136069" y="4813881"/>
              <a:ext cx="13603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rth America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371B573-2AC8-9EB6-AD44-29F2C4F33648}"/>
                </a:ext>
              </a:extLst>
            </p:cNvPr>
            <p:cNvSpPr txBox="1"/>
            <p:nvPr/>
          </p:nvSpPr>
          <p:spPr>
            <a:xfrm>
              <a:off x="5357432" y="5173788"/>
              <a:ext cx="19019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inents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EF1AD79-D834-287A-2358-1BEA6308E286}"/>
                </a:ext>
              </a:extLst>
            </p:cNvPr>
            <p:cNvSpPr txBox="1"/>
            <p:nvPr/>
          </p:nvSpPr>
          <p:spPr>
            <a:xfrm rot="16200000">
              <a:off x="1308981" y="3140261"/>
              <a:ext cx="19632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tance to centroi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7124D9D-3603-673B-AD29-8E80F0E235A5}"/>
                </a:ext>
              </a:extLst>
            </p:cNvPr>
            <p:cNvSpPr txBox="1"/>
            <p:nvPr/>
          </p:nvSpPr>
          <p:spPr>
            <a:xfrm rot="16200000">
              <a:off x="2300846" y="4431321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B90654C-7A15-085D-BBB7-C4C6DABA6DCC}"/>
                </a:ext>
              </a:extLst>
            </p:cNvPr>
            <p:cNvSpPr txBox="1"/>
            <p:nvPr/>
          </p:nvSpPr>
          <p:spPr>
            <a:xfrm rot="16200000">
              <a:off x="2302765" y="3626162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78C1E04-148F-A506-20E1-3F6AEDE39FE8}"/>
                </a:ext>
              </a:extLst>
            </p:cNvPr>
            <p:cNvSpPr txBox="1"/>
            <p:nvPr/>
          </p:nvSpPr>
          <p:spPr>
            <a:xfrm rot="16200000">
              <a:off x="2300860" y="2824292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2251053-3E50-D68D-9BBF-6425B127795D}"/>
                </a:ext>
              </a:extLst>
            </p:cNvPr>
            <p:cNvSpPr txBox="1"/>
            <p:nvPr/>
          </p:nvSpPr>
          <p:spPr>
            <a:xfrm rot="16200000">
              <a:off x="2300016" y="2015247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DA7934B-25B8-D5AF-8FE2-57030C4D0725}"/>
                </a:ext>
              </a:extLst>
            </p:cNvPr>
            <p:cNvSpPr txBox="1"/>
            <p:nvPr/>
          </p:nvSpPr>
          <p:spPr>
            <a:xfrm rot="16200000">
              <a:off x="2301183" y="4033844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3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188C1B7-516A-F9B8-03E4-9FEA957B7AEA}"/>
                </a:ext>
              </a:extLst>
            </p:cNvPr>
            <p:cNvSpPr txBox="1"/>
            <p:nvPr/>
          </p:nvSpPr>
          <p:spPr>
            <a:xfrm rot="16200000">
              <a:off x="2301241" y="3226702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56B8E62-98A2-58D5-5829-6C5538D3E437}"/>
                </a:ext>
              </a:extLst>
            </p:cNvPr>
            <p:cNvSpPr txBox="1"/>
            <p:nvPr/>
          </p:nvSpPr>
          <p:spPr>
            <a:xfrm rot="16200000">
              <a:off x="2300438" y="2419976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7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3419172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>
            <a:extLst>
              <a:ext uri="{FF2B5EF4-FFF2-40B4-BE49-F238E27FC236}">
                <a16:creationId xmlns:a16="http://schemas.microsoft.com/office/drawing/2014/main" id="{18C1B188-2FE4-F809-0B45-90CDC204A7BA}"/>
              </a:ext>
            </a:extLst>
          </p:cNvPr>
          <p:cNvGrpSpPr/>
          <p:nvPr/>
        </p:nvGrpSpPr>
        <p:grpSpPr>
          <a:xfrm>
            <a:off x="2117520" y="1223962"/>
            <a:ext cx="7878967" cy="4824389"/>
            <a:chOff x="2117520" y="1223962"/>
            <a:chExt cx="7878967" cy="4824389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FF3EFD6A-4F17-6420-359C-CB347A8BD9B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95512" y="1223962"/>
              <a:ext cx="7800975" cy="4410075"/>
            </a:xfrm>
            <a:prstGeom prst="rect">
              <a:avLst/>
            </a:prstGeom>
          </p:spPr>
        </p:pic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5EE7A38E-2C86-D590-A06D-EBC06E6A8069}"/>
                </a:ext>
              </a:extLst>
            </p:cNvPr>
            <p:cNvSpPr/>
            <p:nvPr/>
          </p:nvSpPr>
          <p:spPr>
            <a:xfrm>
              <a:off x="2195512" y="1938020"/>
              <a:ext cx="616269" cy="273812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1C1C11F5-E30A-DDF6-38FA-B8C236B99933}"/>
                </a:ext>
              </a:extLst>
            </p:cNvPr>
            <p:cNvSpPr/>
            <p:nvPr/>
          </p:nvSpPr>
          <p:spPr>
            <a:xfrm rot="5400000">
              <a:off x="5942016" y="1824113"/>
              <a:ext cx="667804" cy="66886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46A843DA-732F-3990-5156-1CEF32627FAE}"/>
                </a:ext>
              </a:extLst>
            </p:cNvPr>
            <p:cNvSpPr txBox="1"/>
            <p:nvPr/>
          </p:nvSpPr>
          <p:spPr>
            <a:xfrm>
              <a:off x="4146958" y="5762644"/>
              <a:ext cx="4322900" cy="28570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i="0" u="none" strike="noStrike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6.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ta diversity dispersion across days of age (P &lt; 0.001). 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27B3CC6-00A2-7A60-CEE7-E437A48D66BF}"/>
                </a:ext>
              </a:extLst>
            </p:cNvPr>
            <p:cNvSpPr txBox="1"/>
            <p:nvPr/>
          </p:nvSpPr>
          <p:spPr>
            <a:xfrm>
              <a:off x="3365182" y="4813244"/>
              <a:ext cx="8919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to 20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9211CB8-197A-98FF-150B-D2BB556A6627}"/>
                </a:ext>
              </a:extLst>
            </p:cNvPr>
            <p:cNvSpPr txBox="1"/>
            <p:nvPr/>
          </p:nvSpPr>
          <p:spPr>
            <a:xfrm>
              <a:off x="4482948" y="4811218"/>
              <a:ext cx="11469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 to 50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B4C1CFF-053F-07F4-824C-5A1552C9611E}"/>
                </a:ext>
              </a:extLst>
            </p:cNvPr>
            <p:cNvSpPr txBox="1"/>
            <p:nvPr/>
          </p:nvSpPr>
          <p:spPr>
            <a:xfrm>
              <a:off x="5814251" y="4811088"/>
              <a:ext cx="9387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 to 10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56FBCB2-F358-0FF6-522C-3384F022F955}"/>
                </a:ext>
              </a:extLst>
            </p:cNvPr>
            <p:cNvSpPr txBox="1"/>
            <p:nvPr/>
          </p:nvSpPr>
          <p:spPr>
            <a:xfrm>
              <a:off x="6987829" y="4811088"/>
              <a:ext cx="109061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ess than 5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2A2062D-48C5-CA43-64E1-797CB698B466}"/>
                </a:ext>
              </a:extLst>
            </p:cNvPr>
            <p:cNvSpPr txBox="1"/>
            <p:nvPr/>
          </p:nvSpPr>
          <p:spPr>
            <a:xfrm>
              <a:off x="8287323" y="4812993"/>
              <a:ext cx="9387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lder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33D78E7-4BAD-F6C3-B233-DC237BC49A88}"/>
                </a:ext>
              </a:extLst>
            </p:cNvPr>
            <p:cNvSpPr txBox="1"/>
            <p:nvPr/>
          </p:nvSpPr>
          <p:spPr>
            <a:xfrm>
              <a:off x="5357432" y="5180646"/>
              <a:ext cx="19019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s of age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2F3C645-8E8C-5FDD-10FE-DBF758494560}"/>
                </a:ext>
              </a:extLst>
            </p:cNvPr>
            <p:cNvSpPr txBox="1"/>
            <p:nvPr/>
          </p:nvSpPr>
          <p:spPr>
            <a:xfrm rot="16200000">
              <a:off x="1305171" y="3140261"/>
              <a:ext cx="19632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tance to centroi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8E144D7-43A9-4C62-8D28-628EA503CCF1}"/>
                </a:ext>
              </a:extLst>
            </p:cNvPr>
            <p:cNvSpPr txBox="1"/>
            <p:nvPr/>
          </p:nvSpPr>
          <p:spPr>
            <a:xfrm rot="16200000">
              <a:off x="2300886" y="4312943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3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9C18D15-17BA-0B1B-F139-7B04DDC1D664}"/>
                </a:ext>
              </a:extLst>
            </p:cNvPr>
            <p:cNvSpPr txBox="1"/>
            <p:nvPr/>
          </p:nvSpPr>
          <p:spPr>
            <a:xfrm rot="16200000">
              <a:off x="2300008" y="3406469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F8088BA-DEB9-F0C5-79A7-DA5F4FAB194E}"/>
                </a:ext>
              </a:extLst>
            </p:cNvPr>
            <p:cNvSpPr txBox="1"/>
            <p:nvPr/>
          </p:nvSpPr>
          <p:spPr>
            <a:xfrm rot="16200000">
              <a:off x="2301625" y="2950374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03BAAD4-EEC0-0358-C951-D65E13AEC8C9}"/>
                </a:ext>
              </a:extLst>
            </p:cNvPr>
            <p:cNvSpPr txBox="1"/>
            <p:nvPr/>
          </p:nvSpPr>
          <p:spPr>
            <a:xfrm rot="16200000">
              <a:off x="2300444" y="2047737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67500A4-41D8-9733-EA54-4C18D94B70BA}"/>
                </a:ext>
              </a:extLst>
            </p:cNvPr>
            <p:cNvSpPr txBox="1"/>
            <p:nvPr/>
          </p:nvSpPr>
          <p:spPr>
            <a:xfrm rot="16200000">
              <a:off x="2302622" y="3854916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F072FF2-5976-C26A-A614-B008BFE45AE9}"/>
                </a:ext>
              </a:extLst>
            </p:cNvPr>
            <p:cNvSpPr txBox="1"/>
            <p:nvPr/>
          </p:nvSpPr>
          <p:spPr>
            <a:xfrm rot="16200000">
              <a:off x="2298981" y="2494279"/>
              <a:ext cx="756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7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8367441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3AB193FC-64DC-4224-26CE-3E327BAE395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36949914"/>
              </p:ext>
            </p:extLst>
          </p:nvPr>
        </p:nvGraphicFramePr>
        <p:xfrm>
          <a:off x="1724924" y="971902"/>
          <a:ext cx="8742151" cy="4914195"/>
        </p:xfrm>
        <a:graphic>
          <a:graphicData uri="http://schemas.openxmlformats.org/drawingml/2006/table">
            <a:tbl>
              <a:tblPr/>
              <a:tblGrid>
                <a:gridCol w="1940697">
                  <a:extLst>
                    <a:ext uri="{9D8B030D-6E8A-4147-A177-3AD203B41FA5}">
                      <a16:colId xmlns:a16="http://schemas.microsoft.com/office/drawing/2014/main" val="2275123399"/>
                    </a:ext>
                  </a:extLst>
                </a:gridCol>
                <a:gridCol w="2038355">
                  <a:extLst>
                    <a:ext uri="{9D8B030D-6E8A-4147-A177-3AD203B41FA5}">
                      <a16:colId xmlns:a16="http://schemas.microsoft.com/office/drawing/2014/main" val="4169514488"/>
                    </a:ext>
                  </a:extLst>
                </a:gridCol>
                <a:gridCol w="1580766">
                  <a:extLst>
                    <a:ext uri="{9D8B030D-6E8A-4147-A177-3AD203B41FA5}">
                      <a16:colId xmlns:a16="http://schemas.microsoft.com/office/drawing/2014/main" val="995103847"/>
                    </a:ext>
                  </a:extLst>
                </a:gridCol>
                <a:gridCol w="1643165">
                  <a:extLst>
                    <a:ext uri="{9D8B030D-6E8A-4147-A177-3AD203B41FA5}">
                      <a16:colId xmlns:a16="http://schemas.microsoft.com/office/drawing/2014/main" val="4017746233"/>
                    </a:ext>
                  </a:extLst>
                </a:gridCol>
                <a:gridCol w="1539168">
                  <a:extLst>
                    <a:ext uri="{9D8B030D-6E8A-4147-A177-3AD203B41FA5}">
                      <a16:colId xmlns:a16="http://schemas.microsoft.com/office/drawing/2014/main" val="513064658"/>
                    </a:ext>
                  </a:extLst>
                </a:gridCol>
              </a:tblGrid>
              <a:tr h="497640">
                <a:tc gridSpan="5"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ble S1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mmary table of dispersion ANOVA and PERMANOVA results. </a:t>
                      </a:r>
                    </a:p>
                  </a:txBody>
                  <a:tcPr marL="7620" marR="7620" marT="762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t">
                        <a:buNone/>
                      </a:pP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t">
                        <a:buNone/>
                      </a:pP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t">
                        <a:buNone/>
                      </a:pP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t">
                        <a:buNone/>
                      </a:pP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41441339"/>
                  </a:ext>
                </a:extLst>
              </a:tr>
              <a:tr h="497640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tor</a:t>
                      </a:r>
                    </a:p>
                  </a:txBody>
                  <a:tcPr marL="7620" marR="7620" marT="762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persion ANOVA </a:t>
                      </a:r>
                      <a:b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</a:p>
                  </a:txBody>
                  <a:tcPr marL="7620" marR="7620" marT="762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MANOVA </a:t>
                      </a:r>
                    </a:p>
                    <a:p>
                      <a:pPr algn="ctr" fontAlgn="t">
                        <a:buNone/>
                      </a:pP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</a:p>
                  </a:txBody>
                  <a:tcPr marL="7620" marR="7620" marT="762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MANOVA </a:t>
                      </a:r>
                      <a:b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²</a:t>
                      </a:r>
                    </a:p>
                  </a:txBody>
                  <a:tcPr marL="7620" marR="7620" marT="762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MANOVA </a:t>
                      </a:r>
                      <a:b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-statistic</a:t>
                      </a:r>
                    </a:p>
                  </a:txBody>
                  <a:tcPr marL="7620" marR="7620" marT="762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9400601"/>
                  </a:ext>
                </a:extLst>
              </a:tr>
              <a:tr h="55984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stinal Segment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8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4.4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33019961"/>
                  </a:ext>
                </a:extLst>
              </a:tr>
              <a:tr h="55984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rd Type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4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.96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9970143"/>
                  </a:ext>
                </a:extLst>
              </a:tr>
              <a:tr h="55984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usin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5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56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46411"/>
                  </a:ext>
                </a:extLst>
              </a:tr>
              <a:tr h="55984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pervariable Region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6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.03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6582754"/>
                  </a:ext>
                </a:extLst>
              </a:tr>
              <a:tr h="55984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inent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2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29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6432998"/>
                  </a:ext>
                </a:extLst>
              </a:tr>
              <a:tr h="55984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9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88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9179044"/>
                  </a:ext>
                </a:extLst>
              </a:tr>
              <a:tr h="55984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Projects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04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3964407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773793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4</TotalTime>
  <Words>252</Words>
  <Application>Microsoft Office PowerPoint</Application>
  <PresentationFormat>Widescreen</PresentationFormat>
  <Paragraphs>123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uediger Hauck</dc:creator>
  <cp:lastModifiedBy>Ruediger Hauck</cp:lastModifiedBy>
  <cp:revision>2</cp:revision>
  <dcterms:created xsi:type="dcterms:W3CDTF">2025-09-06T18:43:23Z</dcterms:created>
  <dcterms:modified xsi:type="dcterms:W3CDTF">2025-09-08T23:07:29Z</dcterms:modified>
</cp:coreProperties>
</file>